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9BE24-30C3-45E8-B51F-4127DB4F59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B5461-AEA6-4BCD-B9CB-7C64BB39A8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886F4-552E-4335-8DF1-C0EC7C4A31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6084F-12D5-4544-9FC3-BD7D47C8A5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503AA-DB2C-4C2D-AE19-A5CFCFDCD1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5DD0B8-E116-4173-98EC-90FA19289D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F17D0-31B2-451F-98FA-19C5710AE9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193E1-2E40-4B2E-8DBE-6FDDE560CE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B1C7F-BCFF-4E1C-9104-A1287AB446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35E8C-7BC6-4CC7-80EF-4E0C05565E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4BD4C-E89B-469E-834F-20F1F87945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A58E7-BB75-467D-94BE-EE9B868E42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74E545-F12B-4AC0-91E0-70F95EDFE12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968480" y="5470560"/>
            <a:ext cx="2486160" cy="4348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11560" y="5851440"/>
            <a:ext cx="38930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lds of expression compared with lymphoid standard in log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2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04920" y="635040"/>
            <a:ext cx="1539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Cytolytic pathway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25440" y="927000"/>
            <a:ext cx="1843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441520" y="635040"/>
            <a:ext cx="153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ecretory signature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753080" y="624600"/>
            <a:ext cx="411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ell cycle, proliferation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left pane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 and quiescence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right pane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122200" y="635040"/>
            <a:ext cx="38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80" y="635040"/>
            <a:ext cx="38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2"/>
          <a:srcRect l="0" t="0" r="10320" b="0"/>
          <a:stretch/>
        </p:blipFill>
        <p:spPr>
          <a:xfrm>
            <a:off x="6946920" y="901800"/>
            <a:ext cx="2197080" cy="410832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3"/>
          <a:srcRect l="0" t="0" r="10010" b="20994"/>
          <a:stretch/>
        </p:blipFill>
        <p:spPr>
          <a:xfrm>
            <a:off x="4518000" y="942840"/>
            <a:ext cx="2435400" cy="512784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4419720" y="635040"/>
            <a:ext cx="38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Verdana"/>
                <a:ea typeface="宋体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847880" y="4734000"/>
            <a:ext cx="142920" cy="10476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4"/>
          <a:stretch/>
        </p:blipFill>
        <p:spPr>
          <a:xfrm>
            <a:off x="0" y="942840"/>
            <a:ext cx="2066760" cy="392436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5"/>
          <a:srcRect l="0" t="0" r="9813" b="2942"/>
          <a:stretch/>
        </p:blipFill>
        <p:spPr>
          <a:xfrm>
            <a:off x="2043000" y="847800"/>
            <a:ext cx="2276640" cy="4533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04T02:38:06Z</dcterms:created>
  <dc:creator>jiqbal</dc:creator>
  <dc:description/>
  <dc:language>en-US</dc:language>
  <cp:lastModifiedBy>jiqbal</cp:lastModifiedBy>
  <dcterms:modified xsi:type="dcterms:W3CDTF">2007-07-06T01:42:20Z</dcterms:modified>
  <cp:revision>30</cp:revision>
  <dc:subject/>
  <dc:title>Slide 1</dc:title>
</cp:coreProperties>
</file>